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7" d="100"/>
          <a:sy n="77" d="100"/>
        </p:scale>
        <p:origin x="310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19E8FD-76D1-444C-B910-4AB4E30677E1}" type="datetimeFigureOut">
              <a:rPr lang="en-GB" smtClean="0"/>
              <a:t>14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787C60-FBBF-4952-B38A-4D9DB4BEEF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06989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19E8FD-76D1-444C-B910-4AB4E30677E1}" type="datetimeFigureOut">
              <a:rPr lang="en-GB" smtClean="0"/>
              <a:t>14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787C60-FBBF-4952-B38A-4D9DB4BEEF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692822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19E8FD-76D1-444C-B910-4AB4E30677E1}" type="datetimeFigureOut">
              <a:rPr lang="en-GB" smtClean="0"/>
              <a:t>14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787C60-FBBF-4952-B38A-4D9DB4BEEF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683214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19E8FD-76D1-444C-B910-4AB4E30677E1}" type="datetimeFigureOut">
              <a:rPr lang="en-GB" smtClean="0"/>
              <a:t>14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787C60-FBBF-4952-B38A-4D9DB4BEEF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568551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19E8FD-76D1-444C-B910-4AB4E30677E1}" type="datetimeFigureOut">
              <a:rPr lang="en-GB" smtClean="0"/>
              <a:t>14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787C60-FBBF-4952-B38A-4D9DB4BEEF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327021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19E8FD-76D1-444C-B910-4AB4E30677E1}" type="datetimeFigureOut">
              <a:rPr lang="en-GB" smtClean="0"/>
              <a:t>14/0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787C60-FBBF-4952-B38A-4D9DB4BEEF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302156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19E8FD-76D1-444C-B910-4AB4E30677E1}" type="datetimeFigureOut">
              <a:rPr lang="en-GB" smtClean="0"/>
              <a:t>14/01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787C60-FBBF-4952-B38A-4D9DB4BEEF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254246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19E8FD-76D1-444C-B910-4AB4E30677E1}" type="datetimeFigureOut">
              <a:rPr lang="en-GB" smtClean="0"/>
              <a:t>14/01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787C60-FBBF-4952-B38A-4D9DB4BEEF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814964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19E8FD-76D1-444C-B910-4AB4E30677E1}" type="datetimeFigureOut">
              <a:rPr lang="en-GB" smtClean="0"/>
              <a:t>14/01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787C60-FBBF-4952-B38A-4D9DB4BEEF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532624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19E8FD-76D1-444C-B910-4AB4E30677E1}" type="datetimeFigureOut">
              <a:rPr lang="en-GB" smtClean="0"/>
              <a:t>14/0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787C60-FBBF-4952-B38A-4D9DB4BEEF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405557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19E8FD-76D1-444C-B910-4AB4E30677E1}" type="datetimeFigureOut">
              <a:rPr lang="en-GB" smtClean="0"/>
              <a:t>14/0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787C60-FBBF-4952-B38A-4D9DB4BEEF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041312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19E8FD-76D1-444C-B910-4AB4E30677E1}" type="datetimeFigureOut">
              <a:rPr lang="en-GB" smtClean="0"/>
              <a:t>14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787C60-FBBF-4952-B38A-4D9DB4BEEF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139110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Group 10">
            <a:extLst>
              <a:ext uri="{FF2B5EF4-FFF2-40B4-BE49-F238E27FC236}">
                <a16:creationId xmlns:a16="http://schemas.microsoft.com/office/drawing/2014/main" id="{4E1C6748-3783-4A16-BACE-7AF95228A65C}"/>
              </a:ext>
            </a:extLst>
          </p:cNvPr>
          <p:cNvGrpSpPr/>
          <p:nvPr/>
        </p:nvGrpSpPr>
        <p:grpSpPr>
          <a:xfrm>
            <a:off x="340423" y="621631"/>
            <a:ext cx="3467490" cy="3336594"/>
            <a:chOff x="30412" y="3264130"/>
            <a:chExt cx="2527826" cy="2571954"/>
          </a:xfrm>
        </p:grpSpPr>
        <p:grpSp>
          <p:nvGrpSpPr>
            <p:cNvPr id="12" name="Group 11">
              <a:extLst>
                <a:ext uri="{FF2B5EF4-FFF2-40B4-BE49-F238E27FC236}">
                  <a16:creationId xmlns:a16="http://schemas.microsoft.com/office/drawing/2014/main" id="{148DA5CC-2B0C-40F5-BFF4-FE3B1FEC6E10}"/>
                </a:ext>
              </a:extLst>
            </p:cNvPr>
            <p:cNvGrpSpPr/>
            <p:nvPr/>
          </p:nvGrpSpPr>
          <p:grpSpPr>
            <a:xfrm>
              <a:off x="30412" y="3264130"/>
              <a:ext cx="2527826" cy="2338301"/>
              <a:chOff x="391633" y="3264130"/>
              <a:chExt cx="2262403" cy="2338301"/>
            </a:xfrm>
          </p:grpSpPr>
          <p:pic>
            <p:nvPicPr>
              <p:cNvPr id="14" name="Picture 13">
                <a:extLst>
                  <a:ext uri="{FF2B5EF4-FFF2-40B4-BE49-F238E27FC236}">
                    <a16:creationId xmlns:a16="http://schemas.microsoft.com/office/drawing/2014/main" id="{4C394CF6-C658-43BB-ABC9-F8C8B92D3C0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1760" t="5756" r="24611" b="1550"/>
              <a:stretch/>
            </p:blipFill>
            <p:spPr>
              <a:xfrm>
                <a:off x="391633" y="3552670"/>
                <a:ext cx="1935926" cy="2049761"/>
              </a:xfrm>
              <a:prstGeom prst="rect">
                <a:avLst/>
              </a:prstGeom>
            </p:spPr>
          </p:pic>
          <p:sp>
            <p:nvSpPr>
              <p:cNvPr id="15" name="Oval 14">
                <a:extLst>
                  <a:ext uri="{FF2B5EF4-FFF2-40B4-BE49-F238E27FC236}">
                    <a16:creationId xmlns:a16="http://schemas.microsoft.com/office/drawing/2014/main" id="{FCB3A7AF-49B5-4F6C-BE77-B4FF284BC598}"/>
                  </a:ext>
                </a:extLst>
              </p:cNvPr>
              <p:cNvSpPr/>
              <p:nvPr/>
            </p:nvSpPr>
            <p:spPr>
              <a:xfrm>
                <a:off x="500004" y="3264130"/>
                <a:ext cx="197899" cy="255613"/>
              </a:xfrm>
              <a:prstGeom prst="ellipse">
                <a:avLst/>
              </a:prstGeom>
              <a:noFill/>
              <a:ln w="15875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GB" sz="1400" b="1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A71C66A4-008C-46EE-92D1-B4B4FBA2BECF}"/>
                  </a:ext>
                </a:extLst>
              </p:cNvPr>
              <p:cNvSpPr txBox="1"/>
              <p:nvPr/>
            </p:nvSpPr>
            <p:spPr>
              <a:xfrm>
                <a:off x="1429294" y="3623651"/>
                <a:ext cx="122474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igh (n=413)</a:t>
                </a:r>
                <a:endParaRPr lang="en-GB" sz="8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FBAECAB4-0B89-4EC0-9F70-45185EA5973B}"/>
                  </a:ext>
                </a:extLst>
              </p:cNvPr>
              <p:cNvSpPr txBox="1"/>
              <p:nvPr/>
            </p:nvSpPr>
            <p:spPr>
              <a:xfrm>
                <a:off x="786566" y="4390041"/>
                <a:ext cx="122474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egative/Low (n=293)</a:t>
                </a:r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6C4B30E5-0D77-4EA3-ADAA-3C6281B3293D}"/>
                  </a:ext>
                </a:extLst>
              </p:cNvPr>
              <p:cNvSpPr txBox="1"/>
              <p:nvPr/>
            </p:nvSpPr>
            <p:spPr>
              <a:xfrm>
                <a:off x="803955" y="5036817"/>
                <a:ext cx="122474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og Rank 0.81;</a:t>
                </a:r>
                <a:r>
                  <a:rPr lang="en-GB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=0.366</a:t>
                </a:r>
              </a:p>
            </p:txBody>
          </p:sp>
        </p:grp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3FA1B15A-801C-4EEB-B4CC-B08A7C6F6B63}"/>
                </a:ext>
              </a:extLst>
            </p:cNvPr>
            <p:cNvSpPr txBox="1"/>
            <p:nvPr/>
          </p:nvSpPr>
          <p:spPr>
            <a:xfrm>
              <a:off x="874974" y="5589863"/>
              <a:ext cx="122474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uminal</a:t>
              </a:r>
              <a:r>
                <a:rPr lang="en-GB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</a:t>
              </a:r>
            </a:p>
          </p:txBody>
        </p:sp>
      </p:grpSp>
      <p:grpSp>
        <p:nvGrpSpPr>
          <p:cNvPr id="19" name="Group 18">
            <a:extLst>
              <a:ext uri="{FF2B5EF4-FFF2-40B4-BE49-F238E27FC236}">
                <a16:creationId xmlns:a16="http://schemas.microsoft.com/office/drawing/2014/main" id="{258E5098-69A1-4548-877E-65216EDB3256}"/>
              </a:ext>
            </a:extLst>
          </p:cNvPr>
          <p:cNvGrpSpPr/>
          <p:nvPr/>
        </p:nvGrpSpPr>
        <p:grpSpPr>
          <a:xfrm>
            <a:off x="3672493" y="621631"/>
            <a:ext cx="3329557" cy="3336594"/>
            <a:chOff x="2278475" y="3294850"/>
            <a:chExt cx="2751465" cy="2553802"/>
          </a:xfrm>
        </p:grpSpPr>
        <p:grpSp>
          <p:nvGrpSpPr>
            <p:cNvPr id="20" name="Group 19">
              <a:extLst>
                <a:ext uri="{FF2B5EF4-FFF2-40B4-BE49-F238E27FC236}">
                  <a16:creationId xmlns:a16="http://schemas.microsoft.com/office/drawing/2014/main" id="{3C938560-1761-40EE-9DE9-3C709059CC6A}"/>
                </a:ext>
              </a:extLst>
            </p:cNvPr>
            <p:cNvGrpSpPr/>
            <p:nvPr/>
          </p:nvGrpSpPr>
          <p:grpSpPr>
            <a:xfrm>
              <a:off x="2278475" y="3294850"/>
              <a:ext cx="2751465" cy="2301179"/>
              <a:chOff x="2382983" y="3286141"/>
              <a:chExt cx="2590441" cy="2301179"/>
            </a:xfrm>
          </p:grpSpPr>
          <p:pic>
            <p:nvPicPr>
              <p:cNvPr id="22" name="Picture 21">
                <a:extLst>
                  <a:ext uri="{FF2B5EF4-FFF2-40B4-BE49-F238E27FC236}">
                    <a16:creationId xmlns:a16="http://schemas.microsoft.com/office/drawing/2014/main" id="{ACB10470-C57D-49F7-980E-FD99E458358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1630" t="4568" r="24771" b="1574"/>
              <a:stretch/>
            </p:blipFill>
            <p:spPr>
              <a:xfrm>
                <a:off x="2382983" y="3537559"/>
                <a:ext cx="2133600" cy="2049761"/>
              </a:xfrm>
              <a:prstGeom prst="rect">
                <a:avLst/>
              </a:prstGeom>
            </p:spPr>
          </p:pic>
          <p:sp>
            <p:nvSpPr>
              <p:cNvPr id="23" name="Oval 22">
                <a:extLst>
                  <a:ext uri="{FF2B5EF4-FFF2-40B4-BE49-F238E27FC236}">
                    <a16:creationId xmlns:a16="http://schemas.microsoft.com/office/drawing/2014/main" id="{EF210ABC-E18B-4CCC-A03A-789C9885D1F4}"/>
                  </a:ext>
                </a:extLst>
              </p:cNvPr>
              <p:cNvSpPr/>
              <p:nvPr/>
            </p:nvSpPr>
            <p:spPr>
              <a:xfrm>
                <a:off x="2558789" y="3286141"/>
                <a:ext cx="197899" cy="255613"/>
              </a:xfrm>
              <a:prstGeom prst="ellipse">
                <a:avLst/>
              </a:prstGeom>
              <a:noFill/>
              <a:ln w="15875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GB" sz="1400" b="1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</a:p>
            </p:txBody>
          </p: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E784EDA1-3EB0-46DC-A802-AF3F2C0522AB}"/>
                  </a:ext>
                </a:extLst>
              </p:cNvPr>
              <p:cNvSpPr txBox="1"/>
              <p:nvPr/>
            </p:nvSpPr>
            <p:spPr>
              <a:xfrm>
                <a:off x="3362632" y="3739881"/>
                <a:ext cx="161079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igh (n=305)</a:t>
                </a:r>
                <a:endParaRPr lang="en-GB" sz="8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EBBDB848-32A4-4D52-91C9-10C04889D2EA}"/>
                  </a:ext>
                </a:extLst>
              </p:cNvPr>
              <p:cNvSpPr txBox="1"/>
              <p:nvPr/>
            </p:nvSpPr>
            <p:spPr>
              <a:xfrm>
                <a:off x="3225605" y="4446464"/>
                <a:ext cx="161079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egative/Low (179)</a:t>
                </a:r>
              </a:p>
            </p:txBody>
          </p: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EDCA0E7F-2760-4BC3-B252-8B74DCD17A19}"/>
                  </a:ext>
                </a:extLst>
              </p:cNvPr>
              <p:cNvSpPr txBox="1"/>
              <p:nvPr/>
            </p:nvSpPr>
            <p:spPr>
              <a:xfrm>
                <a:off x="2714866" y="4999756"/>
                <a:ext cx="161079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og Rank 0.14;</a:t>
                </a:r>
                <a:r>
                  <a:rPr lang="en-GB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=0.707</a:t>
                </a:r>
              </a:p>
            </p:txBody>
          </p:sp>
        </p:grp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D9C975AA-5DC6-4D18-89FA-54EC282F64F0}"/>
                </a:ext>
              </a:extLst>
            </p:cNvPr>
            <p:cNvSpPr txBox="1"/>
            <p:nvPr/>
          </p:nvSpPr>
          <p:spPr>
            <a:xfrm>
              <a:off x="3211540" y="5602431"/>
              <a:ext cx="122474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uminal</a:t>
              </a:r>
              <a:r>
                <a:rPr lang="en-GB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B</a:t>
              </a:r>
            </a:p>
          </p:txBody>
        </p:sp>
      </p:grpSp>
      <p:grpSp>
        <p:nvGrpSpPr>
          <p:cNvPr id="27" name="Group 26">
            <a:extLst>
              <a:ext uri="{FF2B5EF4-FFF2-40B4-BE49-F238E27FC236}">
                <a16:creationId xmlns:a16="http://schemas.microsoft.com/office/drawing/2014/main" id="{3A2A0B82-F1DB-4F0C-AB36-549143F0FDBA}"/>
              </a:ext>
            </a:extLst>
          </p:cNvPr>
          <p:cNvGrpSpPr/>
          <p:nvPr/>
        </p:nvGrpSpPr>
        <p:grpSpPr>
          <a:xfrm>
            <a:off x="340424" y="3915573"/>
            <a:ext cx="2967112" cy="3293711"/>
            <a:chOff x="4619892" y="3308073"/>
            <a:chExt cx="2262881" cy="2523015"/>
          </a:xfrm>
        </p:grpSpPr>
        <p:grpSp>
          <p:nvGrpSpPr>
            <p:cNvPr id="28" name="Group 27">
              <a:extLst>
                <a:ext uri="{FF2B5EF4-FFF2-40B4-BE49-F238E27FC236}">
                  <a16:creationId xmlns:a16="http://schemas.microsoft.com/office/drawing/2014/main" id="{2EC0420C-32C2-4BEE-A616-0904934EC950}"/>
                </a:ext>
              </a:extLst>
            </p:cNvPr>
            <p:cNvGrpSpPr/>
            <p:nvPr/>
          </p:nvGrpSpPr>
          <p:grpSpPr>
            <a:xfrm>
              <a:off x="4619892" y="3308073"/>
              <a:ext cx="2262881" cy="2243742"/>
              <a:chOff x="4724401" y="3281946"/>
              <a:chExt cx="2085494" cy="2243742"/>
            </a:xfrm>
          </p:grpSpPr>
          <p:pic>
            <p:nvPicPr>
              <p:cNvPr id="30" name="Picture 29">
                <a:extLst>
                  <a:ext uri="{FF2B5EF4-FFF2-40B4-BE49-F238E27FC236}">
                    <a16:creationId xmlns:a16="http://schemas.microsoft.com/office/drawing/2014/main" id="{15FA1BC7-B304-4D21-B497-10E2B20AC09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2100" t="6044" r="24828" b="2338"/>
              <a:stretch/>
            </p:blipFill>
            <p:spPr>
              <a:xfrm>
                <a:off x="4724401" y="3537560"/>
                <a:ext cx="2085494" cy="1988128"/>
              </a:xfrm>
              <a:prstGeom prst="rect">
                <a:avLst/>
              </a:prstGeom>
            </p:spPr>
          </p:pic>
          <p:sp>
            <p:nvSpPr>
              <p:cNvPr id="31" name="Oval 30">
                <a:extLst>
                  <a:ext uri="{FF2B5EF4-FFF2-40B4-BE49-F238E27FC236}">
                    <a16:creationId xmlns:a16="http://schemas.microsoft.com/office/drawing/2014/main" id="{48DF1FD9-BC7E-46D4-8269-794B1AF94E9A}"/>
                  </a:ext>
                </a:extLst>
              </p:cNvPr>
              <p:cNvSpPr/>
              <p:nvPr/>
            </p:nvSpPr>
            <p:spPr>
              <a:xfrm>
                <a:off x="4819851" y="3281946"/>
                <a:ext cx="197899" cy="255613"/>
              </a:xfrm>
              <a:prstGeom prst="ellipse">
                <a:avLst/>
              </a:prstGeom>
              <a:noFill/>
              <a:ln w="15875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GB" sz="1400" b="1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</a:t>
                </a:r>
              </a:p>
            </p:txBody>
          </p:sp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D44C13DD-0C60-48B1-AB0B-A8F17AD61BAB}"/>
                  </a:ext>
                </a:extLst>
              </p:cNvPr>
              <p:cNvSpPr txBox="1"/>
              <p:nvPr/>
            </p:nvSpPr>
            <p:spPr>
              <a:xfrm>
                <a:off x="5585153" y="3739881"/>
                <a:ext cx="122474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igh (n=84)</a:t>
                </a:r>
                <a:endParaRPr lang="en-GB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DEB33BE6-0C8D-4B05-A3ED-8574556AEE2D}"/>
                  </a:ext>
                </a:extLst>
              </p:cNvPr>
              <p:cNvSpPr txBox="1"/>
              <p:nvPr/>
            </p:nvSpPr>
            <p:spPr>
              <a:xfrm>
                <a:off x="5448126" y="4446464"/>
                <a:ext cx="122474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egative/Low (n=242)</a:t>
                </a:r>
              </a:p>
            </p:txBody>
          </p:sp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7480C116-562B-4E65-92E8-417A078DADDC}"/>
                  </a:ext>
                </a:extLst>
              </p:cNvPr>
              <p:cNvSpPr txBox="1"/>
              <p:nvPr/>
            </p:nvSpPr>
            <p:spPr>
              <a:xfrm>
                <a:off x="5022667" y="4985232"/>
                <a:ext cx="122474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og Rank 0.28;p=</a:t>
                </a:r>
                <a:r>
                  <a:rPr lang="en-GB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598</a:t>
                </a:r>
              </a:p>
            </p:txBody>
          </p:sp>
        </p:grp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F9605DD2-B438-4654-9C23-3DE92825953D}"/>
                </a:ext>
              </a:extLst>
            </p:cNvPr>
            <p:cNvSpPr txBox="1"/>
            <p:nvPr/>
          </p:nvSpPr>
          <p:spPr>
            <a:xfrm>
              <a:off x="5607986" y="5584867"/>
              <a:ext cx="122474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asal</a:t>
              </a:r>
            </a:p>
          </p:txBody>
        </p:sp>
      </p:grpSp>
      <p:grpSp>
        <p:nvGrpSpPr>
          <p:cNvPr id="35" name="Group 34">
            <a:extLst>
              <a:ext uri="{FF2B5EF4-FFF2-40B4-BE49-F238E27FC236}">
                <a16:creationId xmlns:a16="http://schemas.microsoft.com/office/drawing/2014/main" id="{0F2B3B5F-0F89-4D2A-9088-EF92FC9AF839}"/>
              </a:ext>
            </a:extLst>
          </p:cNvPr>
          <p:cNvGrpSpPr/>
          <p:nvPr/>
        </p:nvGrpSpPr>
        <p:grpSpPr>
          <a:xfrm>
            <a:off x="3712578" y="3915572"/>
            <a:ext cx="2742368" cy="3293711"/>
            <a:chOff x="6874064" y="3301193"/>
            <a:chExt cx="2191756" cy="2548246"/>
          </a:xfrm>
        </p:grpSpPr>
        <p:grpSp>
          <p:nvGrpSpPr>
            <p:cNvPr id="36" name="Group 35">
              <a:extLst>
                <a:ext uri="{FF2B5EF4-FFF2-40B4-BE49-F238E27FC236}">
                  <a16:creationId xmlns:a16="http://schemas.microsoft.com/office/drawing/2014/main" id="{1747C7B7-31BD-40C1-A8DC-6379F48494E1}"/>
                </a:ext>
              </a:extLst>
            </p:cNvPr>
            <p:cNvGrpSpPr/>
            <p:nvPr/>
          </p:nvGrpSpPr>
          <p:grpSpPr>
            <a:xfrm>
              <a:off x="6874064" y="3301193"/>
              <a:ext cx="2191756" cy="2250622"/>
              <a:chOff x="7023871" y="3301193"/>
              <a:chExt cx="2085494" cy="2148840"/>
            </a:xfrm>
          </p:grpSpPr>
          <p:pic>
            <p:nvPicPr>
              <p:cNvPr id="38" name="Picture 37">
                <a:extLst>
                  <a:ext uri="{FF2B5EF4-FFF2-40B4-BE49-F238E27FC236}">
                    <a16:creationId xmlns:a16="http://schemas.microsoft.com/office/drawing/2014/main" id="{DCC6EA38-F855-498C-BF9B-8163CCD1599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/>
              <a:srcRect l="1497" t="6417" r="24611" b="2374"/>
              <a:stretch/>
            </p:blipFill>
            <p:spPr>
              <a:xfrm>
                <a:off x="7023871" y="3558341"/>
                <a:ext cx="2085494" cy="1891692"/>
              </a:xfrm>
              <a:prstGeom prst="rect">
                <a:avLst/>
              </a:prstGeom>
            </p:spPr>
          </p:pic>
          <p:sp>
            <p:nvSpPr>
              <p:cNvPr id="39" name="Oval 38">
                <a:extLst>
                  <a:ext uri="{FF2B5EF4-FFF2-40B4-BE49-F238E27FC236}">
                    <a16:creationId xmlns:a16="http://schemas.microsoft.com/office/drawing/2014/main" id="{7DB8A8FC-089C-49CC-AFC4-3751507CED84}"/>
                  </a:ext>
                </a:extLst>
              </p:cNvPr>
              <p:cNvSpPr/>
              <p:nvPr/>
            </p:nvSpPr>
            <p:spPr>
              <a:xfrm>
                <a:off x="7113163" y="3301193"/>
                <a:ext cx="197899" cy="255613"/>
              </a:xfrm>
              <a:prstGeom prst="ellipse">
                <a:avLst/>
              </a:prstGeom>
              <a:noFill/>
              <a:ln w="15875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GB" sz="1400" b="1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</a:t>
                </a:r>
              </a:p>
            </p:txBody>
          </p:sp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20E64B34-BEDD-459C-8329-FD6DABA4C430}"/>
                  </a:ext>
                </a:extLst>
              </p:cNvPr>
              <p:cNvSpPr txBox="1"/>
              <p:nvPr/>
            </p:nvSpPr>
            <p:spPr>
              <a:xfrm>
                <a:off x="7884623" y="3654281"/>
                <a:ext cx="1224742" cy="22039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igh (n=76)</a:t>
                </a:r>
                <a:endParaRPr lang="en-GB" sz="8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id="{11DA2EF3-2C5D-4168-8AA2-C57E9C49C22F}"/>
                  </a:ext>
                </a:extLst>
              </p:cNvPr>
              <p:cNvSpPr txBox="1"/>
              <p:nvPr/>
            </p:nvSpPr>
            <p:spPr>
              <a:xfrm>
                <a:off x="7747596" y="4375612"/>
                <a:ext cx="1224742" cy="22039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egative/Low (n=161)</a:t>
                </a:r>
              </a:p>
            </p:txBody>
          </p:sp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id="{BBF5B9D2-4870-491C-8C72-45CF14369577}"/>
                  </a:ext>
                </a:extLst>
              </p:cNvPr>
              <p:cNvSpPr txBox="1"/>
              <p:nvPr/>
            </p:nvSpPr>
            <p:spPr>
              <a:xfrm>
                <a:off x="7454247" y="4910391"/>
                <a:ext cx="1518091" cy="22039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og Rank 0.16;</a:t>
                </a:r>
                <a:r>
                  <a:rPr lang="en-GB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=0.694</a:t>
                </a:r>
              </a:p>
            </p:txBody>
          </p:sp>
        </p:grp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BE135040-376E-4E23-BA6E-C7103882D24D}"/>
                </a:ext>
              </a:extLst>
            </p:cNvPr>
            <p:cNvSpPr txBox="1"/>
            <p:nvPr/>
          </p:nvSpPr>
          <p:spPr>
            <a:xfrm>
              <a:off x="7778674" y="5603218"/>
              <a:ext cx="122474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ER2</a:t>
              </a:r>
              <a:r>
                <a:rPr lang="en-GB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9926907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5</TotalTime>
  <Words>93</Words>
  <Application>Microsoft Office PowerPoint</Application>
  <PresentationFormat>A4 Paper (210x297 mm)</PresentationFormat>
  <Paragraphs>2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University of Nottingham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l ansari Rokaya</dc:creator>
  <cp:lastModifiedBy>Chitra Joseph</cp:lastModifiedBy>
  <cp:revision>5</cp:revision>
  <dcterms:created xsi:type="dcterms:W3CDTF">2017-12-22T19:07:47Z</dcterms:created>
  <dcterms:modified xsi:type="dcterms:W3CDTF">2018-01-14T23:01:52Z</dcterms:modified>
</cp:coreProperties>
</file>